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673" r:id="rId2"/>
  </p:sldIdLst>
  <p:sldSz cx="9144000" cy="6858000" type="screen4x3"/>
  <p:notesSz cx="6800850" cy="99329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47" autoAdjust="0"/>
    <p:restoredTop sz="94660"/>
  </p:normalViewPr>
  <p:slideViewPr>
    <p:cSldViewPr>
      <p:cViewPr varScale="1">
        <p:scale>
          <a:sx n="104" d="100"/>
          <a:sy n="104" d="100"/>
        </p:scale>
        <p:origin x="1776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7" y="8"/>
            <a:ext cx="2947035" cy="496254"/>
          </a:xfrm>
          <a:prstGeom prst="rect">
            <a:avLst/>
          </a:prstGeom>
        </p:spPr>
        <p:txBody>
          <a:bodyPr vert="horz" lIns="91377" tIns="45688" rIns="91377" bIns="4568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2249" y="8"/>
            <a:ext cx="2947035" cy="496254"/>
          </a:xfrm>
          <a:prstGeom prst="rect">
            <a:avLst/>
          </a:prstGeom>
        </p:spPr>
        <p:txBody>
          <a:bodyPr vert="horz" lIns="91377" tIns="45688" rIns="91377" bIns="45688" rtlCol="0"/>
          <a:lstStyle>
            <a:lvl1pPr algn="r">
              <a:defRPr sz="1200"/>
            </a:lvl1pPr>
          </a:lstStyle>
          <a:p>
            <a:fld id="{3C1EAC6D-3939-4073-94C4-EBABC104933D}" type="datetimeFigureOut">
              <a:rPr kumimoji="1" lang="ja-JP" altLang="en-US" smtClean="0"/>
              <a:t>2024/8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6125"/>
            <a:ext cx="49657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77" tIns="45688" rIns="91377" bIns="4568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086" y="4718372"/>
            <a:ext cx="5440680" cy="4469449"/>
          </a:xfrm>
          <a:prstGeom prst="rect">
            <a:avLst/>
          </a:prstGeom>
        </p:spPr>
        <p:txBody>
          <a:bodyPr vert="horz" lIns="91377" tIns="45688" rIns="91377" bIns="4568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7" y="9435150"/>
            <a:ext cx="2947035" cy="496253"/>
          </a:xfrm>
          <a:prstGeom prst="rect">
            <a:avLst/>
          </a:prstGeom>
        </p:spPr>
        <p:txBody>
          <a:bodyPr vert="horz" lIns="91377" tIns="45688" rIns="91377" bIns="4568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2249" y="9435150"/>
            <a:ext cx="2947035" cy="496253"/>
          </a:xfrm>
          <a:prstGeom prst="rect">
            <a:avLst/>
          </a:prstGeom>
        </p:spPr>
        <p:txBody>
          <a:bodyPr vert="horz" lIns="91377" tIns="45688" rIns="91377" bIns="45688" rtlCol="0" anchor="b"/>
          <a:lstStyle>
            <a:lvl1pPr algn="r">
              <a:defRPr sz="1200"/>
            </a:lvl1pPr>
          </a:lstStyle>
          <a:p>
            <a:fld id="{9AB9F04A-1BCF-42D5-82FD-B0847764E5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12755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1180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41537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94444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8960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53551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31377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230936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4968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067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8678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3780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6FEDC8-80A1-4604-8BAC-AEEE706A6DB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4/8/22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96AA2E-219B-44E3-92AE-C239F32DFD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74328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2">
            <a:extLst>
              <a:ext uri="{FF2B5EF4-FFF2-40B4-BE49-F238E27FC236}">
                <a16:creationId xmlns:a16="http://schemas.microsoft.com/office/drawing/2014/main" id="{938B963F-3F5A-A692-526E-26226A24DE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7689344"/>
              </p:ext>
            </p:extLst>
          </p:nvPr>
        </p:nvGraphicFramePr>
        <p:xfrm>
          <a:off x="116505" y="1645920"/>
          <a:ext cx="8910990" cy="3566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64396">
                  <a:extLst>
                    <a:ext uri="{9D8B030D-6E8A-4147-A177-3AD203B41FA5}">
                      <a16:colId xmlns:a16="http://schemas.microsoft.com/office/drawing/2014/main" val="2032020765"/>
                    </a:ext>
                  </a:extLst>
                </a:gridCol>
                <a:gridCol w="1782198">
                  <a:extLst>
                    <a:ext uri="{9D8B030D-6E8A-4147-A177-3AD203B41FA5}">
                      <a16:colId xmlns:a16="http://schemas.microsoft.com/office/drawing/2014/main" val="1846014142"/>
                    </a:ext>
                  </a:extLst>
                </a:gridCol>
                <a:gridCol w="1782198">
                  <a:extLst>
                    <a:ext uri="{9D8B030D-6E8A-4147-A177-3AD203B41FA5}">
                      <a16:colId xmlns:a16="http://schemas.microsoft.com/office/drawing/2014/main" val="661091897"/>
                    </a:ext>
                  </a:extLst>
                </a:gridCol>
                <a:gridCol w="1782198">
                  <a:extLst>
                    <a:ext uri="{9D8B030D-6E8A-4147-A177-3AD203B41FA5}">
                      <a16:colId xmlns:a16="http://schemas.microsoft.com/office/drawing/2014/main" val="594782821"/>
                    </a:ext>
                  </a:extLst>
                </a:gridCol>
              </a:tblGrid>
              <a:tr h="21602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ITUTION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Kochi Universit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saka Universit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saka Universit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0834367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ime Period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l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fter 3/1/202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efore 2/28/202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1228359"/>
                  </a:ext>
                </a:extLst>
              </a:tr>
              <a:tr h="1714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racer (</a:t>
                      </a:r>
                      <a:r>
                        <a:rPr lang="en-US" altLang="ja-JP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Bq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2211994"/>
                  </a:ext>
                </a:extLst>
              </a:tr>
              <a:tr h="18515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canner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iemens Symbia T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ymbia </a:t>
                      </a:r>
                      <a:r>
                        <a:rPr lang="en-US" altLang="ja-JP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ntevo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ymbia T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5973852"/>
                  </a:ext>
                </a:extLst>
              </a:tr>
              <a:tr h="19886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ollimator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ME-GP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ME-GP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ME-GP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107867"/>
                  </a:ext>
                </a:extLst>
              </a:tr>
              <a:tr h="21257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trix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8 × 12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8 × 12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8 × 12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8839059"/>
                  </a:ext>
                </a:extLst>
              </a:tr>
              <a:tr h="15428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otation duration (s)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0" dirty="0">
                          <a:solidFill>
                            <a:srgbClr val="37415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0</a:t>
                      </a:r>
                      <a:endParaRPr lang="ja-JP" altLang="ja-JP" sz="12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0" dirty="0">
                          <a:solidFill>
                            <a:srgbClr val="37415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0</a:t>
                      </a:r>
                      <a:endParaRPr lang="ja-JP" altLang="ja-JP" sz="12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0" dirty="0">
                          <a:solidFill>
                            <a:srgbClr val="37415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0</a:t>
                      </a:r>
                      <a:endParaRPr lang="ja-JP" altLang="ja-JP" sz="12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3222068"/>
                  </a:ext>
                </a:extLst>
              </a:tr>
              <a:tr h="2400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otal rotations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 (2x6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0" dirty="0">
                          <a:solidFill>
                            <a:srgbClr val="37415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 (12x1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0" dirty="0">
                          <a:solidFill>
                            <a:srgbClr val="37415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 (12x1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6541191"/>
                  </a:ext>
                </a:extLst>
              </a:tr>
              <a:tr h="25371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hotopeak window (keV)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0" dirty="0">
                          <a:solidFill>
                            <a:srgbClr val="37415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9 ± 10%</a:t>
                      </a:r>
                      <a:endParaRPr lang="ja-JP" altLang="ja-JP" sz="12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0" dirty="0">
                          <a:solidFill>
                            <a:srgbClr val="37415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8 ± 20%</a:t>
                      </a:r>
                      <a:endParaRPr lang="ja-JP" altLang="ja-JP" sz="12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0" dirty="0">
                          <a:solidFill>
                            <a:srgbClr val="37415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8 ± 20%</a:t>
                      </a:r>
                      <a:endParaRPr lang="ja-JP" altLang="ja-JP" sz="120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6313373"/>
                  </a:ext>
                </a:extLst>
              </a:tr>
              <a:tr h="1954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ut-off frequency (cycles/pixel)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0" dirty="0">
                          <a:solidFill>
                            <a:srgbClr val="37415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0" dirty="0">
                          <a:solidFill>
                            <a:srgbClr val="37415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0" dirty="0">
                          <a:solidFill>
                            <a:srgbClr val="37415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2336821"/>
                  </a:ext>
                </a:extLst>
              </a:tr>
              <a:tr h="13712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rder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0758973"/>
                  </a:ext>
                </a:extLst>
              </a:tr>
              <a:tr h="222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lice thickness (mm)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7526437"/>
                  </a:ext>
                </a:extLst>
              </a:tr>
              <a:tr h="24758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hang’s attenuation correction coefficient</a:t>
                      </a:r>
                    </a:p>
                  </a:txBody>
                  <a:tcPr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7/c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5/c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5/c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5298935"/>
                  </a:ext>
                </a:extLst>
              </a:tr>
            </a:tbl>
          </a:graphicData>
        </a:graphic>
      </p:graphicFrame>
      <p:sp>
        <p:nvSpPr>
          <p:cNvPr id="2" name="正方形/長方形 1"/>
          <p:cNvSpPr/>
          <p:nvPr/>
        </p:nvSpPr>
        <p:spPr>
          <a:xfrm>
            <a:off x="116505" y="1268760"/>
            <a:ext cx="402344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GS明朝E"/>
                <a:cs typeface="Times New Roman" panose="02020603050405020304" pitchFamily="18" charset="0"/>
              </a:rPr>
              <a:t>Supplementary Table 1</a:t>
            </a:r>
            <a:r>
              <a:rPr kumimoji="0" lang="ja-JP" altLang="en-US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GS明朝E"/>
                <a:cs typeface="Times New Roman" panose="02020603050405020304" pitchFamily="18" charset="0"/>
              </a:rPr>
              <a:t>　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GS明朝E"/>
                <a:cs typeface="Times New Roman" panose="02020603050405020304" pitchFamily="18" charset="0"/>
              </a:rPr>
              <a:t>SPECT imaging protocols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7015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06</TotalTime>
  <Words>128</Words>
  <Application>Microsoft Office PowerPoint</Application>
  <PresentationFormat>画面に合わせる (4:3)</PresentationFormat>
  <Paragraphs>5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i-reha-ex2</dc:creator>
  <cp:lastModifiedBy>直広 木村</cp:lastModifiedBy>
  <cp:revision>626</cp:revision>
  <cp:lastPrinted>2024-07-05T09:34:34Z</cp:lastPrinted>
  <dcterms:created xsi:type="dcterms:W3CDTF">2016-09-30T08:59:07Z</dcterms:created>
  <dcterms:modified xsi:type="dcterms:W3CDTF">2024-08-22T10:08:18Z</dcterms:modified>
</cp:coreProperties>
</file>